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13716000" cy="6400800"/>
  <p:notesSz cx="6858000" cy="9144000"/>
  <p:defaultTextStyle>
    <a:defPPr>
      <a:defRPr lang="en-US"/>
    </a:defPPr>
    <a:lvl1pPr marL="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378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4D7566-6A8D-4DFF-935D-01FB62AFB54C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3825" y="1143000"/>
            <a:ext cx="66103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9BC0A2-1762-423C-92F3-DB1BCB4D6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983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3825" y="1143000"/>
            <a:ext cx="66103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9BC0A2-1762-423C-92F3-DB1BCB4D63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5705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1047539"/>
            <a:ext cx="10287000" cy="2228427"/>
          </a:xfrm>
        </p:spPr>
        <p:txBody>
          <a:bodyPr anchor="b"/>
          <a:lstStyle>
            <a:lvl1pPr algn="ctr">
              <a:defRPr sz="5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3361902"/>
            <a:ext cx="10287000" cy="1545378"/>
          </a:xfrm>
        </p:spPr>
        <p:txBody>
          <a:bodyPr/>
          <a:lstStyle>
            <a:lvl1pPr marL="0" indent="0" algn="ctr">
              <a:buNone/>
              <a:defRPr sz="2240"/>
            </a:lvl1pPr>
            <a:lvl2pPr marL="426705" indent="0" algn="ctr">
              <a:buNone/>
              <a:defRPr sz="1867"/>
            </a:lvl2pPr>
            <a:lvl3pPr marL="853410" indent="0" algn="ctr">
              <a:buNone/>
              <a:defRPr sz="1680"/>
            </a:lvl3pPr>
            <a:lvl4pPr marL="1280114" indent="0" algn="ctr">
              <a:buNone/>
              <a:defRPr sz="1493"/>
            </a:lvl4pPr>
            <a:lvl5pPr marL="1706819" indent="0" algn="ctr">
              <a:buNone/>
              <a:defRPr sz="1493"/>
            </a:lvl5pPr>
            <a:lvl6pPr marL="2133524" indent="0" algn="ctr">
              <a:buNone/>
              <a:defRPr sz="1493"/>
            </a:lvl6pPr>
            <a:lvl7pPr marL="2560229" indent="0" algn="ctr">
              <a:buNone/>
              <a:defRPr sz="1493"/>
            </a:lvl7pPr>
            <a:lvl8pPr marL="2986933" indent="0" algn="ctr">
              <a:buNone/>
              <a:defRPr sz="1493"/>
            </a:lvl8pPr>
            <a:lvl9pPr marL="3413638" indent="0" algn="ctr">
              <a:buNone/>
              <a:defRPr sz="149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430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946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2" y="340783"/>
            <a:ext cx="2957513" cy="542438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5" y="340783"/>
            <a:ext cx="8701088" cy="542438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352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860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1" y="1595756"/>
            <a:ext cx="11830050" cy="2662555"/>
          </a:xfrm>
        </p:spPr>
        <p:txBody>
          <a:bodyPr anchor="b"/>
          <a:lstStyle>
            <a:lvl1pPr>
              <a:defRPr sz="5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1" y="4283499"/>
            <a:ext cx="11830050" cy="1400175"/>
          </a:xfrm>
        </p:spPr>
        <p:txBody>
          <a:bodyPr/>
          <a:lstStyle>
            <a:lvl1pPr marL="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1pPr>
            <a:lvl2pPr marL="426705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2pPr>
            <a:lvl3pPr marL="85341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28011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4pPr>
            <a:lvl5pPr marL="170681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5pPr>
            <a:lvl6pPr marL="2133524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6pPr>
            <a:lvl7pPr marL="2560229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7pPr>
            <a:lvl8pPr marL="2986933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8pPr>
            <a:lvl9pPr marL="3413638" indent="0">
              <a:buNone/>
              <a:defRPr sz="14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057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1703917"/>
            <a:ext cx="5829300" cy="40612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1703917"/>
            <a:ext cx="5829300" cy="40612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98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340784"/>
            <a:ext cx="11830050" cy="12371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2" y="1569085"/>
            <a:ext cx="5802510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2" y="2338070"/>
            <a:ext cx="5802510" cy="34389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5" y="1569085"/>
            <a:ext cx="5831087" cy="768985"/>
          </a:xfrm>
        </p:spPr>
        <p:txBody>
          <a:bodyPr anchor="b"/>
          <a:lstStyle>
            <a:lvl1pPr marL="0" indent="0">
              <a:buNone/>
              <a:defRPr sz="2240" b="1"/>
            </a:lvl1pPr>
            <a:lvl2pPr marL="426705" indent="0">
              <a:buNone/>
              <a:defRPr sz="1867" b="1"/>
            </a:lvl2pPr>
            <a:lvl3pPr marL="853410" indent="0">
              <a:buNone/>
              <a:defRPr sz="1680" b="1"/>
            </a:lvl3pPr>
            <a:lvl4pPr marL="1280114" indent="0">
              <a:buNone/>
              <a:defRPr sz="1493" b="1"/>
            </a:lvl4pPr>
            <a:lvl5pPr marL="1706819" indent="0">
              <a:buNone/>
              <a:defRPr sz="1493" b="1"/>
            </a:lvl5pPr>
            <a:lvl6pPr marL="2133524" indent="0">
              <a:buNone/>
              <a:defRPr sz="1493" b="1"/>
            </a:lvl6pPr>
            <a:lvl7pPr marL="2560229" indent="0">
              <a:buNone/>
              <a:defRPr sz="1493" b="1"/>
            </a:lvl7pPr>
            <a:lvl8pPr marL="2986933" indent="0">
              <a:buNone/>
              <a:defRPr sz="1493" b="1"/>
            </a:lvl8pPr>
            <a:lvl9pPr marL="3413638" indent="0">
              <a:buNone/>
              <a:defRPr sz="149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5" y="2338070"/>
            <a:ext cx="5831087" cy="34389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11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687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847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26720"/>
            <a:ext cx="4423767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921597"/>
            <a:ext cx="6943725" cy="4548717"/>
          </a:xfrm>
        </p:spPr>
        <p:txBody>
          <a:bodyPr/>
          <a:lstStyle>
            <a:lvl1pPr>
              <a:defRPr sz="2987"/>
            </a:lvl1pPr>
            <a:lvl2pPr>
              <a:defRPr sz="2613"/>
            </a:lvl2pPr>
            <a:lvl3pPr>
              <a:defRPr sz="2240"/>
            </a:lvl3pPr>
            <a:lvl4pPr>
              <a:defRPr sz="1867"/>
            </a:lvl4pPr>
            <a:lvl5pPr>
              <a:defRPr sz="1867"/>
            </a:lvl5pPr>
            <a:lvl6pPr>
              <a:defRPr sz="1867"/>
            </a:lvl6pPr>
            <a:lvl7pPr>
              <a:defRPr sz="1867"/>
            </a:lvl7pPr>
            <a:lvl8pPr>
              <a:defRPr sz="1867"/>
            </a:lvl8pPr>
            <a:lvl9pPr>
              <a:defRPr sz="18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1920240"/>
            <a:ext cx="4423767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508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26720"/>
            <a:ext cx="4423767" cy="1493520"/>
          </a:xfrm>
        </p:spPr>
        <p:txBody>
          <a:bodyPr anchor="b"/>
          <a:lstStyle>
            <a:lvl1pPr>
              <a:defRPr sz="298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921597"/>
            <a:ext cx="6943725" cy="4548717"/>
          </a:xfrm>
        </p:spPr>
        <p:txBody>
          <a:bodyPr anchor="t"/>
          <a:lstStyle>
            <a:lvl1pPr marL="0" indent="0">
              <a:buNone/>
              <a:defRPr sz="2987"/>
            </a:lvl1pPr>
            <a:lvl2pPr marL="426705" indent="0">
              <a:buNone/>
              <a:defRPr sz="2613"/>
            </a:lvl2pPr>
            <a:lvl3pPr marL="853410" indent="0">
              <a:buNone/>
              <a:defRPr sz="2240"/>
            </a:lvl3pPr>
            <a:lvl4pPr marL="1280114" indent="0">
              <a:buNone/>
              <a:defRPr sz="1867"/>
            </a:lvl4pPr>
            <a:lvl5pPr marL="1706819" indent="0">
              <a:buNone/>
              <a:defRPr sz="1867"/>
            </a:lvl5pPr>
            <a:lvl6pPr marL="2133524" indent="0">
              <a:buNone/>
              <a:defRPr sz="1867"/>
            </a:lvl6pPr>
            <a:lvl7pPr marL="2560229" indent="0">
              <a:buNone/>
              <a:defRPr sz="1867"/>
            </a:lvl7pPr>
            <a:lvl8pPr marL="2986933" indent="0">
              <a:buNone/>
              <a:defRPr sz="1867"/>
            </a:lvl8pPr>
            <a:lvl9pPr marL="3413638" indent="0">
              <a:buNone/>
              <a:defRPr sz="18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1920240"/>
            <a:ext cx="4423767" cy="3557482"/>
          </a:xfrm>
        </p:spPr>
        <p:txBody>
          <a:bodyPr/>
          <a:lstStyle>
            <a:lvl1pPr marL="0" indent="0">
              <a:buNone/>
              <a:defRPr sz="1493"/>
            </a:lvl1pPr>
            <a:lvl2pPr marL="426705" indent="0">
              <a:buNone/>
              <a:defRPr sz="1307"/>
            </a:lvl2pPr>
            <a:lvl3pPr marL="853410" indent="0">
              <a:buNone/>
              <a:defRPr sz="1120"/>
            </a:lvl3pPr>
            <a:lvl4pPr marL="1280114" indent="0">
              <a:buNone/>
              <a:defRPr sz="933"/>
            </a:lvl4pPr>
            <a:lvl5pPr marL="1706819" indent="0">
              <a:buNone/>
              <a:defRPr sz="933"/>
            </a:lvl5pPr>
            <a:lvl6pPr marL="2133524" indent="0">
              <a:buNone/>
              <a:defRPr sz="933"/>
            </a:lvl6pPr>
            <a:lvl7pPr marL="2560229" indent="0">
              <a:buNone/>
              <a:defRPr sz="933"/>
            </a:lvl7pPr>
            <a:lvl8pPr marL="2986933" indent="0">
              <a:buNone/>
              <a:defRPr sz="933"/>
            </a:lvl8pPr>
            <a:lvl9pPr marL="3413638" indent="0">
              <a:buNone/>
              <a:defRPr sz="9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76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340784"/>
            <a:ext cx="11830050" cy="12371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1703917"/>
            <a:ext cx="11830050" cy="40612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5932594"/>
            <a:ext cx="308610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44C99-EC27-48BD-A48D-A4BF36EFBB3B}" type="datetimeFigureOut">
              <a:rPr lang="en-US" smtClean="0"/>
              <a:t>17-May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5932594"/>
            <a:ext cx="462915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5932594"/>
            <a:ext cx="308610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9ECA2-E4C9-4EDC-9AAA-49B6E4357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147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53410" rtl="0" eaLnBrk="1" latinLnBrk="0" hangingPunct="1">
        <a:lnSpc>
          <a:spcPct val="90000"/>
        </a:lnSpc>
        <a:spcBef>
          <a:spcPct val="0"/>
        </a:spcBef>
        <a:buNone/>
        <a:defRPr sz="41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3352" indent="-213352" algn="l" defTabSz="8534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1pPr>
      <a:lvl2pPr marL="64005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2pPr>
      <a:lvl3pPr marL="1066762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3pPr>
      <a:lvl4pPr marL="1493467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92017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34687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773581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86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626990" indent="-213352" algn="l" defTabSz="853410" rtl="0" eaLnBrk="1" latinLnBrk="0" hangingPunct="1">
        <a:lnSpc>
          <a:spcPct val="90000"/>
        </a:lnSpc>
        <a:spcBef>
          <a:spcPts val="467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26705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53410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1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4pPr>
      <a:lvl5pPr marL="170681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5pPr>
      <a:lvl6pPr marL="2133524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6pPr>
      <a:lvl7pPr marL="2560229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7pPr>
      <a:lvl8pPr marL="2986933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8pPr>
      <a:lvl9pPr marL="3413638" algn="l" defTabSz="853410" rtl="0" eaLnBrk="1" latinLnBrk="0" hangingPunct="1">
        <a:defRPr sz="1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5091311"/>
              </p:ext>
            </p:extLst>
          </p:nvPr>
        </p:nvGraphicFramePr>
        <p:xfrm>
          <a:off x="152400" y="177798"/>
          <a:ext cx="13462000" cy="61087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65500"/>
                <a:gridCol w="3365500"/>
                <a:gridCol w="3365500"/>
                <a:gridCol w="3365500"/>
              </a:tblGrid>
              <a:tr h="3054351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</a:tr>
              <a:tr h="3054351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pic>
        <p:nvPicPr>
          <p:cNvPr id="3" name="Picture 2" descr="C:\Users\cropphys\Desktop\siva-desktop files-2-5-2016\SPSS\Vigor0.png"/>
          <p:cNvPicPr>
            <a:picLocks noChangeAspect="1" noChangeArrowheads="1"/>
          </p:cNvPicPr>
          <p:nvPr/>
        </p:nvPicPr>
        <p:blipFill>
          <a:blip r:embed="rId3"/>
          <a:srcRect l="3727" t="18605" r="24531" b="8139"/>
          <a:stretch>
            <a:fillRect/>
          </a:stretch>
        </p:blipFill>
        <p:spPr bwMode="auto">
          <a:xfrm>
            <a:off x="241300" y="177799"/>
            <a:ext cx="3086100" cy="2936875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774512" y="198251"/>
            <a:ext cx="157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itchFamily="34" charset="0"/>
              </a:rPr>
              <a:t>Plant vigour score</a:t>
            </a:r>
            <a:endParaRPr lang="en-US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2" descr="C:\Users\cropphys\Desktop\siva-desktop files-2-5-2016\SPSS\PH0.png"/>
          <p:cNvPicPr>
            <a:picLocks noChangeAspect="1" noChangeArrowheads="1"/>
          </p:cNvPicPr>
          <p:nvPr/>
        </p:nvPicPr>
        <p:blipFill>
          <a:blip r:embed="rId4"/>
          <a:srcRect l="3982" t="17647" r="24041" b="7353"/>
          <a:stretch>
            <a:fillRect/>
          </a:stretch>
        </p:blipFill>
        <p:spPr bwMode="auto">
          <a:xfrm>
            <a:off x="3494492" y="187088"/>
            <a:ext cx="3325408" cy="2927586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4588393" y="225188"/>
            <a:ext cx="1377811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lant height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2" descr="C:\Users\cropphys\Desktop\siva-desktop files-2-5-2016\SPSS\la-3d0.png"/>
          <p:cNvPicPr>
            <a:picLocks noChangeAspect="1" noChangeArrowheads="1"/>
          </p:cNvPicPr>
          <p:nvPr/>
        </p:nvPicPr>
        <p:blipFill>
          <a:blip r:embed="rId5"/>
          <a:srcRect l="3982" t="17647" r="24041" b="7353"/>
          <a:stretch>
            <a:fillRect/>
          </a:stretch>
        </p:blipFill>
        <p:spPr bwMode="auto">
          <a:xfrm>
            <a:off x="6877808" y="200735"/>
            <a:ext cx="3303422" cy="2918297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7706838" y="225187"/>
            <a:ext cx="1171575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3D-leaf area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Picture 2" descr="C:\Users\cropphys\Desktop\siva-desktop files-2-5-2016\SPSS\sdw0.png"/>
          <p:cNvPicPr>
            <a:picLocks noChangeAspect="1" noChangeArrowheads="1"/>
          </p:cNvPicPr>
          <p:nvPr/>
        </p:nvPicPr>
        <p:blipFill>
          <a:blip r:embed="rId6"/>
          <a:srcRect l="3982" t="17647" r="24041" b="7353"/>
          <a:stretch>
            <a:fillRect/>
          </a:stretch>
        </p:blipFill>
        <p:spPr bwMode="auto">
          <a:xfrm>
            <a:off x="10239138" y="225187"/>
            <a:ext cx="3381328" cy="2880198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11010260" y="295049"/>
            <a:ext cx="1477704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hoot dry weight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2" descr="C:\Users\cropphys\Desktop\siva-desktop files-2-5-2016\SPSS\ETR-FINAL-1230.png"/>
          <p:cNvPicPr>
            <a:picLocks noChangeAspect="1" noChangeArrowheads="1"/>
          </p:cNvPicPr>
          <p:nvPr/>
        </p:nvPicPr>
        <p:blipFill>
          <a:blip r:embed="rId7"/>
          <a:srcRect l="4217" t="18421" r="24699" b="6391"/>
          <a:stretch>
            <a:fillRect/>
          </a:stretch>
        </p:blipFill>
        <p:spPr bwMode="auto">
          <a:xfrm>
            <a:off x="122830" y="3343701"/>
            <a:ext cx="3371662" cy="2893325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822482" y="3343701"/>
            <a:ext cx="1571624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anspiration rate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Picture 2" descr="C:\Users\cropphys\Desktop\siva-desktop files-2-5-2016\SPSS\TR-FINAL0.png"/>
          <p:cNvPicPr>
            <a:picLocks noChangeAspect="1" noChangeArrowheads="1"/>
          </p:cNvPicPr>
          <p:nvPr/>
        </p:nvPicPr>
        <p:blipFill>
          <a:blip r:embed="rId8"/>
          <a:srcRect l="4286" t="18421" r="23534" b="6391"/>
          <a:stretch>
            <a:fillRect/>
          </a:stretch>
        </p:blipFill>
        <p:spPr bwMode="auto">
          <a:xfrm>
            <a:off x="3603009" y="3343701"/>
            <a:ext cx="3274799" cy="2893325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4094328" y="3317405"/>
            <a:ext cx="2102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vapotranspiration rate</a:t>
            </a:r>
            <a:endParaRPr lang="en-US" sz="12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Picture 2" descr="C:\Users\cropphys\Desktop\siva-desktop files-2-5-2016\SPSS\ETTT0.png"/>
          <p:cNvPicPr>
            <a:picLocks noChangeAspect="1" noChangeArrowheads="1"/>
          </p:cNvPicPr>
          <p:nvPr/>
        </p:nvPicPr>
        <p:blipFill>
          <a:blip r:embed="rId9"/>
          <a:srcRect l="3982" t="17647" r="24041" b="7353"/>
          <a:stretch>
            <a:fillRect/>
          </a:stretch>
        </p:blipFill>
        <p:spPr bwMode="auto">
          <a:xfrm>
            <a:off x="6986325" y="3317405"/>
            <a:ext cx="3252814" cy="2864479"/>
          </a:xfrm>
          <a:prstGeom prst="rect">
            <a:avLst/>
          </a:prstGeom>
          <a:noFill/>
        </p:spPr>
      </p:pic>
      <p:sp>
        <p:nvSpPr>
          <p:cNvPr id="16" name="TextBox 15"/>
          <p:cNvSpPr txBox="1"/>
          <p:nvPr/>
        </p:nvSpPr>
        <p:spPr>
          <a:xfrm>
            <a:off x="7843200" y="3361463"/>
            <a:ext cx="1539064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anspiration 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Picture 3" descr="C:\Users\cropphys\Desktop\siva-desktop files-2-5-2016\SPSS\TTTT-FINAL-10.png"/>
          <p:cNvPicPr>
            <a:picLocks noChangeAspect="1" noChangeArrowheads="1"/>
          </p:cNvPicPr>
          <p:nvPr/>
        </p:nvPicPr>
        <p:blipFill>
          <a:blip r:embed="rId10"/>
          <a:srcRect l="2941" t="17766" r="24118" b="6044"/>
          <a:stretch>
            <a:fillRect/>
          </a:stretch>
        </p:blipFill>
        <p:spPr bwMode="auto">
          <a:xfrm>
            <a:off x="10251830" y="3317403"/>
            <a:ext cx="3368636" cy="2864481"/>
          </a:xfrm>
          <a:prstGeom prst="rect">
            <a:avLst/>
          </a:prstGeom>
          <a:noFill/>
        </p:spPr>
      </p:pic>
      <p:sp>
        <p:nvSpPr>
          <p:cNvPr id="18" name="TextBox 17"/>
          <p:cNvSpPr txBox="1"/>
          <p:nvPr/>
        </p:nvSpPr>
        <p:spPr>
          <a:xfrm>
            <a:off x="11188065" y="3361463"/>
            <a:ext cx="1603958" cy="274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1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vapotranspiration </a:t>
            </a:r>
            <a:endParaRPr lang="en-US" sz="1181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074799" y="2214831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505316" y="503026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283768" y="2182222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106888" y="499299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706838" y="1640142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419917" y="5124204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259811" y="141240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034960" y="5241205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2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540141" y="1457320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2591998" y="5043945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239819" y="503551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42008" y="5016618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74774" y="524120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765728" y="2092089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033926" y="2214831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2382687" y="1764246"/>
            <a:ext cx="4000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 smtClean="0">
                <a:solidFill>
                  <a:srgbClr val="2304DA"/>
                </a:solidFill>
                <a:latin typeface="Arial" pitchFamily="34" charset="0"/>
                <a:cs typeface="Arial" pitchFamily="34" charset="0"/>
              </a:rPr>
              <a:t>P1</a:t>
            </a:r>
            <a:endParaRPr lang="en-US" sz="1013" b="1" dirty="0">
              <a:solidFill>
                <a:srgbClr val="2304DA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89035" y="164529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96257" y="3380375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895920" y="3358829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271882" y="3372941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0653258" y="3361463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H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853998" y="232285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260558" y="253702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0634155" y="292099"/>
            <a:ext cx="319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5543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41</Words>
  <Application>Microsoft Office PowerPoint</Application>
  <PresentationFormat>Custom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vasakthi</dc:creator>
  <cp:lastModifiedBy>Sivasakthi</cp:lastModifiedBy>
  <cp:revision>3</cp:revision>
  <dcterms:created xsi:type="dcterms:W3CDTF">2017-05-16T18:50:25Z</dcterms:created>
  <dcterms:modified xsi:type="dcterms:W3CDTF">2017-05-16T19:11:34Z</dcterms:modified>
</cp:coreProperties>
</file>